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100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03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autzky</a:t>
            </a:r>
            <a:r>
              <a:rPr lang="en-GB" dirty="0"/>
              <a:t>-Willer et al (2023) Diabetologia DOI 10.1007/s00125-023-05891-x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. Created in BioRender.com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ex-specific risks and sex and gender differences in risk factors and clinical features of men and women with type 2 diabete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94B978F-ACA9-AB11-B072-9826B3378A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94941" y="1179672"/>
            <a:ext cx="6570141" cy="4498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Illustration of the most important sex differences in the complications and possible effects of pharmacological therapy and management of patients with type 2 diabete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8934785-EAAF-1B62-735E-71485A357E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0882" y="1471852"/>
            <a:ext cx="6942236" cy="40072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2F6051B-F97A-72DB-A84C-35E0045E63AA}"/>
              </a:ext>
            </a:extLst>
          </p:cNvPr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autzky</a:t>
            </a:r>
            <a:r>
              <a:rPr lang="en-GB" dirty="0"/>
              <a:t>-Willer et al (2023) Diabetologia DOI 10.1007/s00125-023-05891-x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. Created in BioRender.com</a:t>
            </a:r>
          </a:p>
        </p:txBody>
      </p:sp>
    </p:spTree>
    <p:extLst>
      <p:ext uri="{BB962C8B-B14F-4D97-AF65-F5344CB8AC3E}">
        <p14:creationId xmlns:p14="http://schemas.microsoft.com/office/powerpoint/2010/main" val="1023012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37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1</cp:revision>
  <dcterms:created xsi:type="dcterms:W3CDTF">2016-06-15T12:53:43Z</dcterms:created>
  <dcterms:modified xsi:type="dcterms:W3CDTF">2023-03-07T13:23:08Z</dcterms:modified>
</cp:coreProperties>
</file>